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45"/>
    <p:restoredTop sz="94676"/>
  </p:normalViewPr>
  <p:slideViewPr>
    <p:cSldViewPr snapToGrid="0" snapToObjects="1">
      <p:cViewPr varScale="1">
        <p:scale>
          <a:sx n="78" d="100"/>
          <a:sy n="78" d="100"/>
        </p:scale>
        <p:origin x="200" y="5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A50CD0E-FF6A-D04B-80F3-C25A5F99D2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8E1AE2E-430F-1B4A-AB3A-734FC37C04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6A38ECD-44EB-C842-AF28-8378702434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9F56E57-793D-A44F-A8DD-07AE5D48C1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A6E211C-47FF-0E40-BDFF-2A6428127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7406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FF89106-35D5-7D4D-970C-37B308412A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BA87E1C-9AD7-4C41-960F-FA25B13BB5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2407D74-A5D6-A44A-92AD-53BAF03F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131AD2A-CB85-C249-9A78-2B4D34635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5F2D278-09EF-884A-8483-C564E0D2E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6667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3BC1C19-2D67-0341-A8D5-B7D2AA027E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0633AB4-5C77-9840-A4A9-B7B2A55BEF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68305D-9C6D-3B44-87B8-C09CEA0070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C2739A8-234D-1249-BA7E-81E94B8DE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48B0A75-76A9-3244-8F3E-4E7656D32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2098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DFBD20F-E6E9-A145-A1B9-3798AD6351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69D8C0C-DF8E-5F49-AE63-45173C7DE3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824A834-DC1C-A640-93D1-72B8174AD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2826C94-BDD9-CB45-B03B-28DFFE1EA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DC4D5A4-E64B-3F44-BB7C-9DD024E98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9248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C5E246-FDBA-7C42-A047-D6F0C42DD8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EA419BB-DC8C-364A-B337-E034C45048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889EF59-FE31-AE41-8DCF-1CA4A4E4B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F12A2DA-8CDB-6447-A6B1-6EC6A85C2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E97F7C3-DF20-E245-A042-61E8A1949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5031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57C886E-81AC-0F42-AA73-1AC5457B30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F4396F9-4CE8-EE42-8071-D3239B731D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0841B8B-A7BA-C344-B4E8-CA6BE5EFF7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65C8D8F-ED24-1042-A30F-05CF12BBB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70A4E5C-3B59-0446-AB00-9470D4263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657F57F-2902-2F46-B2CB-8376FACF6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6598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03B5C54-D368-7D46-98DD-2978C344FA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82B758C-540A-D54D-8A7E-4E74856F57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AA9C1BA-3088-F34C-BA2F-EEF9E2FDCF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B9549DBF-C949-624D-97AB-D80B65D8E7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1CA131E-69E0-C946-91C9-568B4BD06A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F0A3455-E48A-C342-B915-A54D3A627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56C9600A-FF6C-BD48-A184-9C226B69B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33DE63D-D992-EF47-8EFF-CDD93750E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5634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E0E1533-4DAD-F442-8D53-3244BDE2C6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04329AC-A143-E045-81C8-4F8CB77BDD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000EA9AB-1120-B94E-9AEB-1789CD9377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8277D8FB-CCC7-1541-BB2F-C5ED8762C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4223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03BD2E0-5E5D-F44A-B9E3-BE4A70265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D31D92BC-33AE-2548-B2C6-6298ABD9F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9A552E23-F0AB-6741-8A29-B7DB10925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8766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932AE27-85EF-3747-A8A5-F985FF4E59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B18D9A9-F6AB-3243-A78B-38E28709CD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9ED6A77-473C-C04E-8367-3A3AC757E5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7A60C71-9C8B-0743-A9C4-D24B69F60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812050B-509D-5448-BC1E-8B52AA46B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9BDC6F0-EBB2-B242-AD99-16FB9B7D0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4122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AE59AC6-E14F-AE48-9290-B7ED3D7ECB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ACC9D21-C80F-0C40-9283-3D99262557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53CF617-E74C-EE46-A371-9BB225C9B9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E1C1072-E4C8-3D43-95F3-C0A31EFCC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3B6F9CF-A589-464E-BC63-6AEBC807C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4DC5DD4-0612-CD4D-8D3F-7FC772215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197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88184EC-D380-AE4B-9D65-D27CF8B374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8942248-9E24-2A43-999E-6CD5A1E50D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C79A242-F08B-9446-A2F9-0CE9F50291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0EA4323-C73E-A647-B34E-44C0047B33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8F824B2-7300-9B46-A90E-665FF49EEC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6423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3478BF7A-67FF-9049-A153-42C6AD6D08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0122" y="1438145"/>
            <a:ext cx="2454566" cy="2454566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E4B18676-72BB-5048-AEA6-E2D4DC31D4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11245" y="1433013"/>
            <a:ext cx="2459697" cy="2459697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0D0DD9F2-64A6-CF4D-AED7-CDAF86DCCFA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0122" y="4026088"/>
            <a:ext cx="2462579" cy="2462579"/>
          </a:xfrm>
          <a:prstGeom prst="rect">
            <a:avLst/>
          </a:prstGeom>
        </p:spPr>
      </p:pic>
      <p:pic>
        <p:nvPicPr>
          <p:cNvPr id="21" name="Image 20">
            <a:extLst>
              <a:ext uri="{FF2B5EF4-FFF2-40B4-BE49-F238E27FC236}">
                <a16:creationId xmlns:a16="http://schemas.microsoft.com/office/drawing/2014/main" id="{80310D7D-D0B3-384C-B3A7-9C95B218B48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11244" y="4026087"/>
            <a:ext cx="2462579" cy="2462579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9A0CC2A4-DBAA-8342-B56C-286F4873615C}"/>
              </a:ext>
            </a:extLst>
          </p:cNvPr>
          <p:cNvSpPr txBox="1"/>
          <p:nvPr/>
        </p:nvSpPr>
        <p:spPr>
          <a:xfrm>
            <a:off x="0" y="15103"/>
            <a:ext cx="12192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Figure 1: Validation of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functional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expression of Gpr101 in a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ransgenic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mouse model</a:t>
            </a:r>
            <a:endParaRPr lang="fr-FR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N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Immunofluorescenc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localization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FLAG-Gpr101 and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Tsh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sections of 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29-week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males and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females</a:t>
            </a:r>
            <a:r>
              <a:rPr lang="fr-FR" sz="1400">
                <a:latin typeface="Arial" panose="020B0604020202020204" pitchFamily="34" charset="0"/>
                <a:cs typeface="Arial" panose="020B0604020202020204" pitchFamily="34" charset="0"/>
              </a:rPr>
              <a:t>, n=4)</a:t>
            </a:r>
            <a:endParaRPr lang="fr-FR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nfoca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microscope – Nikon A1R-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i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immersion objective - x60 magnification – Zoom 2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experimen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repeate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n=3 times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7D298E13-D7C7-A645-A273-C55CDEDD15EC}"/>
              </a:ext>
            </a:extLst>
          </p:cNvPr>
          <p:cNvSpPr txBox="1"/>
          <p:nvPr/>
        </p:nvSpPr>
        <p:spPr>
          <a:xfrm>
            <a:off x="3112655" y="402608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fr-FR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62BBC823-4E1E-2043-8DF4-FFAB0B628CD0}"/>
              </a:ext>
            </a:extLst>
          </p:cNvPr>
          <p:cNvSpPr txBox="1"/>
          <p:nvPr/>
        </p:nvSpPr>
        <p:spPr>
          <a:xfrm>
            <a:off x="483445" y="4026089"/>
            <a:ext cx="195438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sh</a:t>
            </a:r>
            <a:r>
              <a:rPr lang="fr-FR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lexa Fluor 647 </a:t>
            </a:r>
            <a:r>
              <a:rPr lang="fr-FR" sz="14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B8CAD1D2-D95B-7E4C-8EDF-5C3ACB91BE62}"/>
              </a:ext>
            </a:extLst>
          </p:cNvPr>
          <p:cNvSpPr txBox="1"/>
          <p:nvPr/>
        </p:nvSpPr>
        <p:spPr>
          <a:xfrm>
            <a:off x="3112656" y="1433015"/>
            <a:ext cx="244783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AG </a:t>
            </a:r>
          </a:p>
          <a:p>
            <a:r>
              <a:rPr lang="fr-FR" sz="1400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lexa Fluor 488 green)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89B03850-B13C-2C4C-A481-509F4DEB1B24}"/>
              </a:ext>
            </a:extLst>
          </p:cNvPr>
          <p:cNvSpPr txBox="1"/>
          <p:nvPr/>
        </p:nvSpPr>
        <p:spPr>
          <a:xfrm>
            <a:off x="483445" y="1433015"/>
            <a:ext cx="1285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 </a:t>
            </a:r>
            <a:r>
              <a:rPr lang="fr-FR" sz="14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400" b="1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ue</a:t>
            </a:r>
            <a:r>
              <a:rPr lang="fr-FR" sz="14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17770D42-E1CB-D649-BBC3-9128C2A6CFE7}"/>
              </a:ext>
            </a:extLst>
          </p:cNvPr>
          <p:cNvSpPr txBox="1"/>
          <p:nvPr/>
        </p:nvSpPr>
        <p:spPr>
          <a:xfrm>
            <a:off x="483445" y="6488668"/>
            <a:ext cx="2004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bar </a:t>
            </a:r>
            <a:r>
              <a:rPr lang="fr-FR">
                <a:latin typeface="Arial" panose="020B0604020202020204" pitchFamily="34" charset="0"/>
                <a:cs typeface="Arial" panose="020B0604020202020204" pitchFamily="34" charset="0"/>
              </a:rPr>
              <a:t>= 10µm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AC10B67-9B7C-C942-B898-8BB4164F67E3}"/>
              </a:ext>
            </a:extLst>
          </p:cNvPr>
          <p:cNvSpPr/>
          <p:nvPr/>
        </p:nvSpPr>
        <p:spPr>
          <a:xfrm>
            <a:off x="5840346" y="1586903"/>
            <a:ext cx="6096000" cy="86177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cell nuclei</a:t>
            </a:r>
            <a:r>
              <a:rPr lang="en-US" sz="1600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nl-BE" sz="1600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PI</a:t>
            </a:r>
            <a:endParaRPr lang="fr-BE" dirty="0">
              <a:solidFill>
                <a:srgbClr val="00B0F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just">
              <a:buFontTx/>
              <a:buChar char="-"/>
            </a:pP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A6ABDDE-89A1-A540-8102-B6D74187E31A}"/>
              </a:ext>
            </a:extLst>
          </p:cNvPr>
          <p:cNvSpPr/>
          <p:nvPr/>
        </p:nvSpPr>
        <p:spPr>
          <a:xfrm>
            <a:off x="5840346" y="2748816"/>
            <a:ext cx="6096000" cy="156966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FLAG-Gpr101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ary antibody: monoclonal mouse anti-FLAG antibody (Sigma–Aldrich, Cat. No F3165, clone M2, dilution 1:1000)</a:t>
            </a:r>
            <a:r>
              <a:rPr lang="fr-BE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285750" indent="-285750" algn="just">
              <a:buFontTx/>
              <a:buChar char="-"/>
            </a:pPr>
            <a:r>
              <a:rPr lang="fr-BE" sz="1600" dirty="0" err="1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ondary</a:t>
            </a:r>
            <a:r>
              <a:rPr lang="fr-BE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-mouse IgG Fab2 Alexa Fluor 488 conjugate (Cell Signaling Technology, Cat. No 4408S, dilution 1:1000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BE" sz="1600" dirty="0">
              <a:solidFill>
                <a:srgbClr val="00FA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12191ED-9094-254C-A587-35E25B72BD44}"/>
              </a:ext>
            </a:extLst>
          </p:cNvPr>
          <p:cNvSpPr/>
          <p:nvPr/>
        </p:nvSpPr>
        <p:spPr>
          <a:xfrm>
            <a:off x="5840346" y="4857452"/>
            <a:ext cx="6096000" cy="1631216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</a:t>
            </a:r>
            <a:r>
              <a:rPr lang="en-US" sz="1600" u="sng" dirty="0" err="1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sh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imary</a:t>
            </a:r>
            <a:r>
              <a:rPr lang="en-US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antibody: 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polyclonal rabbit anti-</a:t>
            </a:r>
            <a:r>
              <a:rPr lang="en-US" sz="1600" dirty="0" err="1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Tsh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(</a:t>
            </a:r>
            <a:r>
              <a:rPr lang="en-US" sz="1600" dirty="0" err="1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Bioss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antibodies, Cat. No bs-2676R, dilution 1:50)   </a:t>
            </a:r>
            <a:endParaRPr lang="fr-BE" sz="1600" dirty="0">
              <a:solidFill>
                <a:srgbClr val="FF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just">
              <a:buFontTx/>
              <a:buChar char="-"/>
            </a:pPr>
            <a:r>
              <a:rPr lang="fr-BE" sz="16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ondary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abbit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H+L) F(ab’)2 fragment Alexa Fluor 647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njugate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echnology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Cat. No 4414, dilution 1:1000) </a:t>
            </a:r>
          </a:p>
        </p:txBody>
      </p:sp>
    </p:spTree>
    <p:extLst>
      <p:ext uri="{BB962C8B-B14F-4D97-AF65-F5344CB8AC3E}">
        <p14:creationId xmlns:p14="http://schemas.microsoft.com/office/powerpoint/2010/main" val="17216408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9</TotalTime>
  <Words>206</Words>
  <Application>Microsoft Macintosh PowerPoint</Application>
  <PresentationFormat>Grand écran</PresentationFormat>
  <Paragraphs>2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Yu Mincho</vt:lpstr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22</cp:revision>
  <dcterms:created xsi:type="dcterms:W3CDTF">2020-05-09T12:35:08Z</dcterms:created>
  <dcterms:modified xsi:type="dcterms:W3CDTF">2020-05-27T16:58:32Z</dcterms:modified>
</cp:coreProperties>
</file>